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797675" cy="987425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84946" autoAdjust="0"/>
  </p:normalViewPr>
  <p:slideViewPr>
    <p:cSldViewPr>
      <p:cViewPr>
        <p:scale>
          <a:sx n="81" d="100"/>
          <a:sy n="81" d="100"/>
        </p:scale>
        <p:origin x="-1896" y="35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1B0A1B-3563-480C-A5D7-EC5A8640C916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17725" y="741363"/>
            <a:ext cx="2562225" cy="37020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690269"/>
            <a:ext cx="5438140" cy="444341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B071AD-4F90-4F73-965E-897CB0D68BB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876244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117725" y="741363"/>
            <a:ext cx="2562225" cy="3702050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fr-FR" sz="1200" b="1" kern="120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igure 2: </a:t>
            </a:r>
            <a:r>
              <a:rPr lang="fr-FR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Effet de l’inhibition de PKD1 sur l’organisation du cytosquelette d’actine et l’expression des </a:t>
            </a:r>
            <a:r>
              <a:rPr lang="fr-FR" sz="1200" b="1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adhérines</a:t>
            </a:r>
            <a:r>
              <a:rPr lang="fr-FR" sz="1200" b="1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E et N </a:t>
            </a:r>
            <a:r>
              <a:rPr lang="fr-FR" sz="1200" b="1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ans les cellules de mélanome M2 </a:t>
            </a:r>
            <a:endParaRPr lang="fr-FR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Les cellules ont été ensemencées sur des lamelles et incubées pendant 2 jours avant le traitement avec l’inhibiteur Gö6976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u l’inhibiteur Gö6983 à la concentration de 1 µM 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durant différents temps. A l’issue du traitement, les cellules ont été perméabilisées et fixées puis marquées A)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ar la 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halloïdine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couplée au 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luorochrome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lexa 488, B) par les anticorps 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nti-N-</a:t>
            </a:r>
            <a:r>
              <a:rPr lang="fr-FR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adhérine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fr-FR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nti-IgG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de lapin couplé au </a:t>
            </a:r>
            <a:r>
              <a:rPr lang="fr-FR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luorochrome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lexa 594 ou C) 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par les anticorps anti-E-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adhérine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/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anti-IgG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de lapin couplé au 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fluorochrome</a:t>
            </a:r>
            <a:r>
              <a:rPr lang="fr-FR" sz="1200" kern="120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Alexa 594. Ensuite, les lamelles ont été analysées à l’aide d’un microscope inversé à </a:t>
            </a:r>
            <a:r>
              <a:rPr lang="fr-FR" sz="1200" kern="120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épifluorescence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 ou à l’aide d’un microscope </a:t>
            </a:r>
            <a:r>
              <a:rPr lang="fr-FR" sz="1200" kern="1200" baseline="0" dirty="0" err="1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confocale</a:t>
            </a:r>
            <a:r>
              <a:rPr lang="fr-FR" sz="1200" kern="1200" baseline="0" dirty="0" smtClean="0">
                <a:solidFill>
                  <a:schemeClr val="tx1"/>
                </a:solidFill>
                <a:latin typeface="+mn-lt"/>
                <a:ea typeface="+mn-ea"/>
                <a:cs typeface="+mn-cs"/>
              </a:rPr>
              <a:t>.</a:t>
            </a:r>
            <a:endParaRPr lang="fr-FR" sz="1200" kern="1200" dirty="0" smtClean="0">
              <a:solidFill>
                <a:schemeClr val="tx1"/>
              </a:solidFill>
              <a:latin typeface="+mn-lt"/>
              <a:ea typeface="+mn-ea"/>
              <a:cs typeface="+mn-cs"/>
            </a:endParaRPr>
          </a:p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B071AD-4F90-4F73-965E-897CB0D68BB6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6" y="3338691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1" y="3338691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1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CF793-5932-43E0-ADC5-300E07948895}" type="datetimeFigureOut">
              <a:rPr lang="fr-FR" smtClean="0"/>
              <a:pPr/>
              <a:t>8/1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E0CF46-76CD-4841-8EDC-D6C2374F2CBB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7688204"/>
              </p:ext>
            </p:extLst>
          </p:nvPr>
        </p:nvGraphicFramePr>
        <p:xfrm>
          <a:off x="653752" y="992560"/>
          <a:ext cx="5943600" cy="326135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384376"/>
                <a:gridCol w="2559224"/>
              </a:tblGrid>
              <a:tr h="284226">
                <a:tc gridSpan="2">
                  <a:txBody>
                    <a:bodyPr/>
                    <a:lstStyle/>
                    <a:p>
                      <a:pPr algn="just"/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Correlation between </a:t>
                      </a:r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PKD1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expression and </a:t>
                      </a:r>
                      <a:r>
                        <a:rPr lang="en-US" sz="1400" b="1" baseline="0" dirty="0" err="1" smtClean="0">
                          <a:latin typeface="Arial"/>
                          <a:cs typeface="Arial"/>
                        </a:rPr>
                        <a:t>mesenchymal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features in M2, M4T2, G1, T1 and I5 melanoma cell lines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prstClr val="black">
                          <a:lumMod val="95000"/>
                          <a:lumOff val="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prstClr val="black">
                          <a:lumMod val="95000"/>
                          <a:lumOff val="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 sz="1400" b="1" dirty="0">
                        <a:solidFill>
                          <a:srgbClr val="000000"/>
                        </a:solidFill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b="1" dirty="0" err="1" smtClean="0">
                          <a:latin typeface="Arial"/>
                          <a:cs typeface="Arial"/>
                        </a:rPr>
                        <a:t>Clonogenicity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prstClr val="black">
                          <a:lumMod val="95000"/>
                          <a:lumOff val="5000"/>
                        </a:prst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rgbClr val="BFBFBF"/>
                    </a:solidFil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Pearson correlation coefficient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0.973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i="1" dirty="0" smtClean="0">
                          <a:latin typeface="Arial"/>
                          <a:cs typeface="Arial"/>
                        </a:rPr>
                        <a:t>p</a:t>
                      </a:r>
                      <a:endParaRPr lang="en-US" sz="1400" b="0" i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003</a:t>
                      </a:r>
                      <a:endParaRPr lang="en-US" sz="1400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Migration (Closure % at 24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hours)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solidFill>
                      <a:srgbClr val="BFBFBF"/>
                    </a:solidFil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Pearson correlation coefficient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0.772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i="1" dirty="0" smtClean="0">
                          <a:latin typeface="Arial"/>
                          <a:cs typeface="Arial"/>
                        </a:rPr>
                        <a:t>p</a:t>
                      </a:r>
                      <a:endParaRPr lang="en-US" sz="1400" b="0" i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0.063</a:t>
                      </a:r>
                      <a:endParaRPr lang="en-US" sz="1400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b="1" dirty="0" smtClean="0">
                          <a:latin typeface="Arial"/>
                          <a:cs typeface="Arial"/>
                        </a:rPr>
                        <a:t>Proliferation (MTT OD570 at day</a:t>
                      </a:r>
                      <a:r>
                        <a:rPr lang="en-US" sz="1400" b="1" baseline="0" dirty="0" smtClean="0">
                          <a:latin typeface="Arial"/>
                          <a:cs typeface="Arial"/>
                        </a:rPr>
                        <a:t> 6)</a:t>
                      </a:r>
                      <a:endParaRPr lang="en-US" sz="1400" b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dirty="0" smtClean="0">
                          <a:latin typeface="Arial"/>
                          <a:cs typeface="Arial"/>
                        </a:rPr>
                        <a:t>Pearson correlation coefficient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b="0" dirty="0" smtClean="0">
                          <a:latin typeface="Arial"/>
                          <a:cs typeface="Arial"/>
                        </a:rPr>
                        <a:t>0.805</a:t>
                      </a:r>
                      <a:endParaRPr lang="en-US" sz="14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</a:tr>
              <a:tr h="284226">
                <a:tc>
                  <a:txBody>
                    <a:bodyPr/>
                    <a:lstStyle/>
                    <a:p>
                      <a:r>
                        <a:rPr lang="en-US" sz="1400" i="1" dirty="0" smtClean="0">
                          <a:latin typeface="Arial"/>
                          <a:cs typeface="Arial"/>
                        </a:rPr>
                        <a:t>p</a:t>
                      </a:r>
                      <a:endParaRPr lang="en-US" sz="1400" b="0" i="1" dirty="0">
                        <a:latin typeface="Arial"/>
                        <a:cs typeface="Arial"/>
                      </a:endParaRPr>
                    </a:p>
                  </a:txBody>
                  <a:tcPr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sz="1400" smtClean="0">
                          <a:latin typeface="Arial"/>
                          <a:cs typeface="Arial"/>
                        </a:rPr>
                        <a:t>0.05</a:t>
                      </a:r>
                      <a:endParaRPr lang="en-US" sz="1400" dirty="0" smtClean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06</TotalTime>
  <Words>204</Words>
  <Application>Microsoft Macintosh PowerPoint</Application>
  <PresentationFormat>A4 Paper (210x297 mm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aroline</dc:creator>
  <cp:lastModifiedBy>Manale Karam Doldur</cp:lastModifiedBy>
  <cp:revision>97</cp:revision>
  <cp:lastPrinted>2016-08-15T06:13:47Z</cp:lastPrinted>
  <dcterms:created xsi:type="dcterms:W3CDTF">2014-05-06T06:46:46Z</dcterms:created>
  <dcterms:modified xsi:type="dcterms:W3CDTF">2016-08-17T11:36:09Z</dcterms:modified>
</cp:coreProperties>
</file>